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88E26C2-9614-45BA-BB62-5E112092BCF6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F273195-816E-4F97-94F8-81A8C5FA9708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492BA1D-E188-445F-ADD3-99D5805E5E36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657BE4D-D499-447B-8EC5-78B0CA4BA877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E74E1E3-A548-48CE-8674-0EC66D18257F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9897B17-36D8-4B6E-B86D-4099880D6E2C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727A280-585B-4DD7-AD6C-3E3C2D1DC879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A92AB14-E750-423F-B153-1468ADF6E196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07436E1-1B2C-4240-B0E8-CBBAA7F27AAB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1641102-A61C-49AC-8A64-3CD15B1B2323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9AB8BDE-F0A3-4D9E-AB8A-AF96A99A64B3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B6D3CFB-8AC8-4A18-AFBD-969397CA912E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E88DF5-FD99-4EB8-875A-03074B40AC71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1" descr=""/>
          <p:cNvPicPr/>
          <p:nvPr/>
        </p:nvPicPr>
        <p:blipFill>
          <a:blip r:embed="rId1"/>
          <a:srcRect l="0" t="0" r="0" b="19996"/>
          <a:stretch/>
        </p:blipFill>
        <p:spPr>
          <a:xfrm>
            <a:off x="3276720" y="4952880"/>
            <a:ext cx="4919400" cy="1600200"/>
          </a:xfrm>
          <a:prstGeom prst="rect">
            <a:avLst/>
          </a:prstGeom>
          <a:ln w="0">
            <a:noFill/>
          </a:ln>
        </p:spPr>
      </p:pic>
      <p:sp>
        <p:nvSpPr>
          <p:cNvPr id="40" name="Rectangle 2"/>
          <p:cNvSpPr/>
          <p:nvPr/>
        </p:nvSpPr>
        <p:spPr>
          <a:xfrm>
            <a:off x="5303880" y="4724280"/>
            <a:ext cx="2257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Sequenom Methylation Ana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Rectangle 3"/>
          <p:cNvSpPr/>
          <p:nvPr/>
        </p:nvSpPr>
        <p:spPr>
          <a:xfrm>
            <a:off x="3122640" y="304920"/>
            <a:ext cx="5335560" cy="6324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3352680" y="457200"/>
            <a:ext cx="4876920" cy="380988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5"/>
          <p:cNvSpPr/>
          <p:nvPr/>
        </p:nvSpPr>
        <p:spPr>
          <a:xfrm>
            <a:off x="4782960" y="853920"/>
            <a:ext cx="837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pG isla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4848120" y="1252440"/>
            <a:ext cx="759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ranscrip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4667760" y="1649520"/>
            <a:ext cx="1125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ranscript Sta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4863600" y="1981080"/>
            <a:ext cx="539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ver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9"/>
          <p:cNvSpPr/>
          <p:nvPr/>
        </p:nvSpPr>
        <p:spPr>
          <a:xfrm>
            <a:off x="4863600" y="2362320"/>
            <a:ext cx="539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ver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4834080" y="3200400"/>
            <a:ext cx="615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stis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4834080" y="2743200"/>
            <a:ext cx="615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stis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2"/>
          <p:cNvSpPr/>
          <p:nvPr/>
        </p:nvSpPr>
        <p:spPr>
          <a:xfrm>
            <a:off x="4927320" y="3581280"/>
            <a:ext cx="413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S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4927320" y="3962520"/>
            <a:ext cx="413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S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4"/>
          <p:cNvSpPr/>
          <p:nvPr/>
        </p:nvSpPr>
        <p:spPr>
          <a:xfrm>
            <a:off x="3983040" y="2095560"/>
            <a:ext cx="914400" cy="35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no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Scaled log2 rati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5"/>
          <p:cNvSpPr/>
          <p:nvPr/>
        </p:nvSpPr>
        <p:spPr>
          <a:xfrm flipV="1">
            <a:off x="6616800" y="1676160"/>
            <a:ext cx="288720" cy="1116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6"/>
          <p:cNvSpPr/>
          <p:nvPr/>
        </p:nvSpPr>
        <p:spPr>
          <a:xfrm>
            <a:off x="6611760" y="1682640"/>
            <a:ext cx="1800" cy="168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7"/>
          <p:cNvSpPr/>
          <p:nvPr/>
        </p:nvSpPr>
        <p:spPr>
          <a:xfrm>
            <a:off x="6802200" y="1230480"/>
            <a:ext cx="763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m10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8"/>
          <p:cNvSpPr/>
          <p:nvPr/>
        </p:nvSpPr>
        <p:spPr>
          <a:xfrm>
            <a:off x="6324480" y="838080"/>
            <a:ext cx="457200" cy="3429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9"/>
          <p:cNvSpPr/>
          <p:nvPr/>
        </p:nvSpPr>
        <p:spPr>
          <a:xfrm flipH="1">
            <a:off x="3733920" y="4267080"/>
            <a:ext cx="2590560" cy="9144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0"/>
          <p:cNvSpPr/>
          <p:nvPr/>
        </p:nvSpPr>
        <p:spPr>
          <a:xfrm>
            <a:off x="6781680" y="4267080"/>
            <a:ext cx="1295640" cy="9144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1"/>
          <p:cNvSpPr/>
          <p:nvPr/>
        </p:nvSpPr>
        <p:spPr>
          <a:xfrm>
            <a:off x="4382640" y="5562720"/>
            <a:ext cx="539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ver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2"/>
          <p:cNvSpPr/>
          <p:nvPr/>
        </p:nvSpPr>
        <p:spPr>
          <a:xfrm>
            <a:off x="4352760" y="5715000"/>
            <a:ext cx="615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stis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3"/>
          <p:cNvSpPr/>
          <p:nvPr/>
        </p:nvSpPr>
        <p:spPr>
          <a:xfrm>
            <a:off x="4165200" y="6338880"/>
            <a:ext cx="127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thylated Test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4"/>
          <p:cNvSpPr/>
          <p:nvPr/>
        </p:nvSpPr>
        <p:spPr>
          <a:xfrm>
            <a:off x="4300560" y="5410080"/>
            <a:ext cx="658800" cy="21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no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ver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5"/>
          <p:cNvSpPr/>
          <p:nvPr/>
        </p:nvSpPr>
        <p:spPr>
          <a:xfrm>
            <a:off x="4422600" y="6019920"/>
            <a:ext cx="413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S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6"/>
          <p:cNvSpPr/>
          <p:nvPr/>
        </p:nvSpPr>
        <p:spPr>
          <a:xfrm>
            <a:off x="4352760" y="5867280"/>
            <a:ext cx="615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stis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7"/>
          <p:cNvSpPr/>
          <p:nvPr/>
        </p:nvSpPr>
        <p:spPr>
          <a:xfrm>
            <a:off x="4424400" y="6186600"/>
            <a:ext cx="413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S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8"/>
          <p:cNvSpPr/>
          <p:nvPr/>
        </p:nvSpPr>
        <p:spPr>
          <a:xfrm>
            <a:off x="101520" y="2309760"/>
            <a:ext cx="2946600" cy="21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no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. Comparison of methylation data between MeDIP/NimbleGen Promoter + CpGi Array and Sequenom MassARRAY: Non CpGi promoter region (randomly selected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51:37Z</dcterms:modified>
  <cp:revision>75</cp:revision>
  <dc:subject/>
  <dc:title>PowerPoint Presentation</dc:title>
</cp:coreProperties>
</file>